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10"/>
  </p:notesMasterIdLst>
  <p:sldIdLst>
    <p:sldId id="270" r:id="rId2"/>
    <p:sldId id="273" r:id="rId3"/>
    <p:sldId id="269" r:id="rId4"/>
    <p:sldId id="274" r:id="rId5"/>
    <p:sldId id="272" r:id="rId6"/>
    <p:sldId id="275" r:id="rId7"/>
    <p:sldId id="271" r:id="rId8"/>
    <p:sldId id="276" r:id="rId9"/>
  </p:sldIdLst>
  <p:sldSz cx="12192000" cy="162560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924" autoAdjust="0"/>
    <p:restoredTop sz="95256" autoAdjust="0"/>
  </p:normalViewPr>
  <p:slideViewPr>
    <p:cSldViewPr snapToGrid="0">
      <p:cViewPr>
        <p:scale>
          <a:sx n="40" d="100"/>
          <a:sy n="40" d="100"/>
        </p:scale>
        <p:origin x="2462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7" Type="http://schemas.openxmlformats.org/officeDocument/2006/relationships/image" Target="../media/image25.emf"/><Relationship Id="rId2" Type="http://schemas.openxmlformats.org/officeDocument/2006/relationships/image" Target="../media/image20.emf"/><Relationship Id="rId1" Type="http://schemas.openxmlformats.org/officeDocument/2006/relationships/image" Target="../media/image19.emf"/><Relationship Id="rId6" Type="http://schemas.openxmlformats.org/officeDocument/2006/relationships/image" Target="../media/image24.emf"/><Relationship Id="rId5" Type="http://schemas.openxmlformats.org/officeDocument/2006/relationships/image" Target="../media/image23.emf"/><Relationship Id="rId4" Type="http://schemas.openxmlformats.org/officeDocument/2006/relationships/image" Target="../media/image22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34.emf"/><Relationship Id="rId3" Type="http://schemas.openxmlformats.org/officeDocument/2006/relationships/image" Target="../media/image29.emf"/><Relationship Id="rId7" Type="http://schemas.openxmlformats.org/officeDocument/2006/relationships/image" Target="../media/image33.emf"/><Relationship Id="rId2" Type="http://schemas.openxmlformats.org/officeDocument/2006/relationships/image" Target="../media/image28.emf"/><Relationship Id="rId1" Type="http://schemas.openxmlformats.org/officeDocument/2006/relationships/image" Target="../media/image27.emf"/><Relationship Id="rId6" Type="http://schemas.openxmlformats.org/officeDocument/2006/relationships/image" Target="../media/image32.emf"/><Relationship Id="rId11" Type="http://schemas.openxmlformats.org/officeDocument/2006/relationships/image" Target="../media/image37.emf"/><Relationship Id="rId5" Type="http://schemas.openxmlformats.org/officeDocument/2006/relationships/image" Target="../media/image31.emf"/><Relationship Id="rId10" Type="http://schemas.openxmlformats.org/officeDocument/2006/relationships/image" Target="../media/image36.emf"/><Relationship Id="rId4" Type="http://schemas.openxmlformats.org/officeDocument/2006/relationships/image" Target="../media/image30.emf"/><Relationship Id="rId9" Type="http://schemas.openxmlformats.org/officeDocument/2006/relationships/image" Target="../media/image3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5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B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5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489B1ECB-5E9B-4B28-98A2-638DF131B80B}" type="datetimeFigureOut">
              <a:rPr lang="en-BE" smtClean="0"/>
              <a:t>23/09/2025</a:t>
            </a:fld>
            <a:endParaRPr lang="en-B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B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4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4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786607B6-F302-46CE-91B2-310D8DF41A43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0947712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0BEB-EA69-4983-A14D-B8AB248E972A}" type="datetimeFigureOut">
              <a:rPr lang="en-BE" smtClean="0"/>
              <a:t>23/09/2025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9224E-AFAA-4D0D-9DCE-8FCBB6EDD383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949962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0BEB-EA69-4983-A14D-B8AB248E972A}" type="datetimeFigureOut">
              <a:rPr lang="en-BE" smtClean="0"/>
              <a:t>23/09/2025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9224E-AFAA-4D0D-9DCE-8FCBB6EDD383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1335451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0BEB-EA69-4983-A14D-B8AB248E972A}" type="datetimeFigureOut">
              <a:rPr lang="en-BE" smtClean="0"/>
              <a:t>23/09/2025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9224E-AFAA-4D0D-9DCE-8FCBB6EDD383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6119922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0BEB-EA69-4983-A14D-B8AB248E972A}" type="datetimeFigureOut">
              <a:rPr lang="en-BE" smtClean="0"/>
              <a:t>23/09/2025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9224E-AFAA-4D0D-9DCE-8FCBB6EDD383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030276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0BEB-EA69-4983-A14D-B8AB248E972A}" type="datetimeFigureOut">
              <a:rPr lang="en-BE" smtClean="0"/>
              <a:t>23/09/2025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9224E-AFAA-4D0D-9DCE-8FCBB6EDD383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4070495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0BEB-EA69-4983-A14D-B8AB248E972A}" type="datetimeFigureOut">
              <a:rPr lang="en-BE" smtClean="0"/>
              <a:t>23/09/2025</a:t>
            </a:fld>
            <a:endParaRPr lang="en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9224E-AFAA-4D0D-9DCE-8FCBB6EDD383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052649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0BEB-EA69-4983-A14D-B8AB248E972A}" type="datetimeFigureOut">
              <a:rPr lang="en-BE" smtClean="0"/>
              <a:t>23/09/2025</a:t>
            </a:fld>
            <a:endParaRPr lang="en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9224E-AFAA-4D0D-9DCE-8FCBB6EDD383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544340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0BEB-EA69-4983-A14D-B8AB248E972A}" type="datetimeFigureOut">
              <a:rPr lang="en-BE" smtClean="0"/>
              <a:t>23/09/2025</a:t>
            </a:fld>
            <a:endParaRPr lang="en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9224E-AFAA-4D0D-9DCE-8FCBB6EDD383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705503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0BEB-EA69-4983-A14D-B8AB248E972A}" type="datetimeFigureOut">
              <a:rPr lang="en-BE" smtClean="0"/>
              <a:t>23/09/2025</a:t>
            </a:fld>
            <a:endParaRPr lang="en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9224E-AFAA-4D0D-9DCE-8FCBB6EDD383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1811954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0BEB-EA69-4983-A14D-B8AB248E972A}" type="datetimeFigureOut">
              <a:rPr lang="en-BE" smtClean="0"/>
              <a:t>23/09/2025</a:t>
            </a:fld>
            <a:endParaRPr lang="en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9224E-AFAA-4D0D-9DCE-8FCBB6EDD383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464583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10BEB-EA69-4983-A14D-B8AB248E972A}" type="datetimeFigureOut">
              <a:rPr lang="en-BE" smtClean="0"/>
              <a:t>23/09/2025</a:t>
            </a:fld>
            <a:endParaRPr lang="en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9224E-AFAA-4D0D-9DCE-8FCBB6EDD383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5887491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A10BEB-EA69-4983-A14D-B8AB248E972A}" type="datetimeFigureOut">
              <a:rPr lang="en-BE" smtClean="0"/>
              <a:t>23/09/2025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E9224E-AFAA-4D0D-9DCE-8FCBB6EDD383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122164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oleObject" Target="../embeddings/oleObject13.bin"/><Relationship Id="rId7" Type="http://schemas.openxmlformats.org/officeDocument/2006/relationships/oleObject" Target="../embeddings/oleObject1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4.emf"/><Relationship Id="rId11" Type="http://schemas.openxmlformats.org/officeDocument/2006/relationships/image" Target="../media/image18.png"/><Relationship Id="rId5" Type="http://schemas.openxmlformats.org/officeDocument/2006/relationships/oleObject" Target="../embeddings/oleObject14.bin"/><Relationship Id="rId10" Type="http://schemas.openxmlformats.org/officeDocument/2006/relationships/image" Target="../media/image17.png"/><Relationship Id="rId4" Type="http://schemas.openxmlformats.org/officeDocument/2006/relationships/image" Target="../media/image13.emf"/><Relationship Id="rId9" Type="http://schemas.openxmlformats.org/officeDocument/2006/relationships/image" Target="../media/image16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8.bin"/><Relationship Id="rId13" Type="http://schemas.openxmlformats.org/officeDocument/2006/relationships/image" Target="../media/image23.emf"/><Relationship Id="rId3" Type="http://schemas.openxmlformats.org/officeDocument/2006/relationships/image" Target="../media/image26.jpg"/><Relationship Id="rId7" Type="http://schemas.openxmlformats.org/officeDocument/2006/relationships/image" Target="../media/image20.emf"/><Relationship Id="rId12" Type="http://schemas.openxmlformats.org/officeDocument/2006/relationships/oleObject" Target="../embeddings/oleObject20.bin"/><Relationship Id="rId17" Type="http://schemas.openxmlformats.org/officeDocument/2006/relationships/image" Target="../media/image25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22.bin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17.bin"/><Relationship Id="rId11" Type="http://schemas.openxmlformats.org/officeDocument/2006/relationships/image" Target="../media/image22.emf"/><Relationship Id="rId5" Type="http://schemas.openxmlformats.org/officeDocument/2006/relationships/image" Target="../media/image19.emf"/><Relationship Id="rId15" Type="http://schemas.openxmlformats.org/officeDocument/2006/relationships/image" Target="../media/image24.emf"/><Relationship Id="rId10" Type="http://schemas.openxmlformats.org/officeDocument/2006/relationships/oleObject" Target="../embeddings/oleObject19.bin"/><Relationship Id="rId4" Type="http://schemas.openxmlformats.org/officeDocument/2006/relationships/oleObject" Target="../embeddings/oleObject16.bin"/><Relationship Id="rId9" Type="http://schemas.openxmlformats.org/officeDocument/2006/relationships/image" Target="../media/image21.emf"/><Relationship Id="rId14" Type="http://schemas.openxmlformats.org/officeDocument/2006/relationships/oleObject" Target="../embeddings/oleObject21.bin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emf"/><Relationship Id="rId13" Type="http://schemas.openxmlformats.org/officeDocument/2006/relationships/oleObject" Target="../embeddings/oleObject28.bin"/><Relationship Id="rId18" Type="http://schemas.openxmlformats.org/officeDocument/2006/relationships/image" Target="../media/image34.emf"/><Relationship Id="rId3" Type="http://schemas.openxmlformats.org/officeDocument/2006/relationships/oleObject" Target="../embeddings/oleObject23.bin"/><Relationship Id="rId21" Type="http://schemas.openxmlformats.org/officeDocument/2006/relationships/oleObject" Target="../embeddings/oleObject32.bin"/><Relationship Id="rId7" Type="http://schemas.openxmlformats.org/officeDocument/2006/relationships/oleObject" Target="../embeddings/oleObject25.bin"/><Relationship Id="rId12" Type="http://schemas.openxmlformats.org/officeDocument/2006/relationships/image" Target="../media/image31.emf"/><Relationship Id="rId17" Type="http://schemas.openxmlformats.org/officeDocument/2006/relationships/oleObject" Target="../embeddings/oleObject30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3.emf"/><Relationship Id="rId20" Type="http://schemas.openxmlformats.org/officeDocument/2006/relationships/image" Target="../media/image35.emf"/><Relationship Id="rId1" Type="http://schemas.openxmlformats.org/officeDocument/2006/relationships/vmlDrawing" Target="../drawings/vmlDrawing4.vml"/><Relationship Id="rId6" Type="http://schemas.openxmlformats.org/officeDocument/2006/relationships/image" Target="../media/image28.emf"/><Relationship Id="rId11" Type="http://schemas.openxmlformats.org/officeDocument/2006/relationships/oleObject" Target="../embeddings/oleObject27.bin"/><Relationship Id="rId24" Type="http://schemas.openxmlformats.org/officeDocument/2006/relationships/image" Target="../media/image37.emf"/><Relationship Id="rId5" Type="http://schemas.openxmlformats.org/officeDocument/2006/relationships/oleObject" Target="../embeddings/oleObject24.bin"/><Relationship Id="rId15" Type="http://schemas.openxmlformats.org/officeDocument/2006/relationships/oleObject" Target="../embeddings/oleObject29.bin"/><Relationship Id="rId23" Type="http://schemas.openxmlformats.org/officeDocument/2006/relationships/oleObject" Target="../embeddings/oleObject33.bin"/><Relationship Id="rId10" Type="http://schemas.openxmlformats.org/officeDocument/2006/relationships/image" Target="../media/image30.emf"/><Relationship Id="rId19" Type="http://schemas.openxmlformats.org/officeDocument/2006/relationships/oleObject" Target="../embeddings/oleObject31.bin"/><Relationship Id="rId4" Type="http://schemas.openxmlformats.org/officeDocument/2006/relationships/image" Target="../media/image27.emf"/><Relationship Id="rId9" Type="http://schemas.openxmlformats.org/officeDocument/2006/relationships/oleObject" Target="../embeddings/oleObject26.bin"/><Relationship Id="rId14" Type="http://schemas.openxmlformats.org/officeDocument/2006/relationships/image" Target="../media/image32.emf"/><Relationship Id="rId22" Type="http://schemas.openxmlformats.org/officeDocument/2006/relationships/image" Target="../media/image36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5DB08252-C9A1-48D1-B842-E2A26D7500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32176965"/>
              </p:ext>
            </p:extLst>
          </p:nvPr>
        </p:nvGraphicFramePr>
        <p:xfrm>
          <a:off x="319338" y="891797"/>
          <a:ext cx="3278187" cy="3008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08" name="Prism 10" r:id="rId3" imgW="3277744" imgH="3008199" progId="Prism10.Document">
                  <p:embed/>
                </p:oleObj>
              </mc:Choice>
              <mc:Fallback>
                <p:oleObj name="Prism 10" r:id="rId3" imgW="3277744" imgH="3008199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5DB08252-C9A1-48D1-B842-E2A26D75007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19338" y="891797"/>
                        <a:ext cx="3278187" cy="3008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A4BD0DA3-55A5-4F8A-B39C-BB054F83D68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1032664"/>
              </p:ext>
            </p:extLst>
          </p:nvPr>
        </p:nvGraphicFramePr>
        <p:xfrm>
          <a:off x="3939723" y="991650"/>
          <a:ext cx="3894137" cy="3008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09" name="Prism 10" r:id="rId5" imgW="3894705" imgH="3008199" progId="Prism10.Document">
                  <p:embed/>
                </p:oleObj>
              </mc:Choice>
              <mc:Fallback>
                <p:oleObj name="Prism 10" r:id="rId5" imgW="3894705" imgH="3008199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A4BD0DA3-55A5-4F8A-B39C-BB054F83D68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39723" y="991650"/>
                        <a:ext cx="3894137" cy="3008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07F4A39D-F58E-4BFE-958A-AC549069FB7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70374"/>
              </p:ext>
            </p:extLst>
          </p:nvPr>
        </p:nvGraphicFramePr>
        <p:xfrm>
          <a:off x="7833860" y="964926"/>
          <a:ext cx="4605337" cy="3008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10" name="Prism 10" r:id="rId7" imgW="4604895" imgH="3008199" progId="Prism10.Document">
                  <p:embed/>
                </p:oleObj>
              </mc:Choice>
              <mc:Fallback>
                <p:oleObj name="Prism 10" r:id="rId7" imgW="4604895" imgH="3008199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07F4A39D-F58E-4BFE-958A-AC549069FB7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833860" y="964926"/>
                        <a:ext cx="4605337" cy="3008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1E081135-CECF-4EE4-A619-5C0A2D513B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75185835"/>
              </p:ext>
            </p:extLst>
          </p:nvPr>
        </p:nvGraphicFramePr>
        <p:xfrm>
          <a:off x="0" y="3951924"/>
          <a:ext cx="5921692" cy="42743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11" name="Prism 10" r:id="rId9" imgW="5700596" imgH="4114361" progId="Prism10.Document">
                  <p:embed/>
                </p:oleObj>
              </mc:Choice>
              <mc:Fallback>
                <p:oleObj name="Prism 10" r:id="rId9" imgW="5700596" imgH="4114361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1E081135-CECF-4EE4-A619-5C0A2D513BA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0" y="3951924"/>
                        <a:ext cx="5921692" cy="42743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A796D2C-8ADF-4404-8D0F-4BC34A6962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3326362"/>
              </p:ext>
            </p:extLst>
          </p:nvPr>
        </p:nvGraphicFramePr>
        <p:xfrm>
          <a:off x="7327900" y="12117116"/>
          <a:ext cx="2384425" cy="2668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12" name="Prism 10" r:id="rId11" imgW="2384697" imgH="2668395" progId="Prism10.Document">
                  <p:embed/>
                </p:oleObj>
              </mc:Choice>
              <mc:Fallback>
                <p:oleObj name="Prism 10" r:id="rId11" imgW="2384697" imgH="266839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327900" y="12117116"/>
                        <a:ext cx="2384425" cy="2668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298E615-BD9D-49A3-9A3A-D4A166E054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7908518"/>
              </p:ext>
            </p:extLst>
          </p:nvPr>
        </p:nvGraphicFramePr>
        <p:xfrm>
          <a:off x="7327900" y="8845278"/>
          <a:ext cx="2384425" cy="2668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13" name="Prism 10" r:id="rId13" imgW="2384697" imgH="2668395" progId="Prism10.Document">
                  <p:embed/>
                </p:oleObj>
              </mc:Choice>
              <mc:Fallback>
                <p:oleObj name="Prism 10" r:id="rId13" imgW="2384697" imgH="266839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7327900" y="8845278"/>
                        <a:ext cx="2384425" cy="2668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02562A86-ECA3-4156-A9B4-4EA9F6707CFC}"/>
              </a:ext>
            </a:extLst>
          </p:cNvPr>
          <p:cNvSpPr txBox="1"/>
          <p:nvPr/>
        </p:nvSpPr>
        <p:spPr>
          <a:xfrm>
            <a:off x="5214315" y="11566022"/>
            <a:ext cx="1763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/>
              <a:t>10 mM Pyruvate</a:t>
            </a:r>
            <a:endParaRPr lang="en-BE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ED2DBB2-1B42-4BB7-BE8C-C7733F4BD0D2}"/>
              </a:ext>
            </a:extLst>
          </p:cNvPr>
          <p:cNvSpPr txBox="1"/>
          <p:nvPr/>
        </p:nvSpPr>
        <p:spPr>
          <a:xfrm>
            <a:off x="2367945" y="8252951"/>
            <a:ext cx="7810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b="1" dirty="0"/>
              <a:t>40 µM Palmitoylcarnitine + 0.5 mM Malate</a:t>
            </a:r>
            <a:endParaRPr lang="en-BE" b="1" dirty="0"/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1B527A8D-9716-4E9B-A65C-49D1572F05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2473524"/>
              </p:ext>
            </p:extLst>
          </p:nvPr>
        </p:nvGraphicFramePr>
        <p:xfrm>
          <a:off x="6137275" y="4552950"/>
          <a:ext cx="2871788" cy="3062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14" name="Prism 10" r:id="rId15" imgW="2872435" imgH="3062913" progId="Prism10.Document">
                  <p:embed/>
                </p:oleObj>
              </mc:Choice>
              <mc:Fallback>
                <p:oleObj name="Prism 10" r:id="rId15" imgW="2872435" imgH="306291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6137275" y="4552950"/>
                        <a:ext cx="2871788" cy="3062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9C56317A-BC1F-4B66-BCD7-C8F7A1E96B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4309396"/>
              </p:ext>
            </p:extLst>
          </p:nvPr>
        </p:nvGraphicFramePr>
        <p:xfrm>
          <a:off x="9313635" y="4928163"/>
          <a:ext cx="2457450" cy="2449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15" name="Prism 10" r:id="rId17" imgW="2457768" imgH="2448819" progId="Prism10.Document">
                  <p:embed/>
                </p:oleObj>
              </mc:Choice>
              <mc:Fallback>
                <p:oleObj name="Prism 10" r:id="rId17" imgW="2457768" imgH="244881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9313635" y="4928163"/>
                        <a:ext cx="2457450" cy="2449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4D1EFD9C-6945-4149-81F1-E2DB2393E9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6373900"/>
              </p:ext>
            </p:extLst>
          </p:nvPr>
        </p:nvGraphicFramePr>
        <p:xfrm>
          <a:off x="4903788" y="8845278"/>
          <a:ext cx="2384425" cy="2668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16" name="Prism 10" r:id="rId19" imgW="2384697" imgH="2668395" progId="Prism10.Document">
                  <p:embed/>
                </p:oleObj>
              </mc:Choice>
              <mc:Fallback>
                <p:oleObj name="Prism 10" r:id="rId19" imgW="2384697" imgH="266839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903788" y="8845278"/>
                        <a:ext cx="2384425" cy="2668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6339F6F1-33D4-4048-BAAB-0E9DA64C2E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9602152"/>
              </p:ext>
            </p:extLst>
          </p:nvPr>
        </p:nvGraphicFramePr>
        <p:xfrm>
          <a:off x="2279650" y="8845278"/>
          <a:ext cx="2384425" cy="2668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17" name="Prism 10" r:id="rId21" imgW="2384697" imgH="2668395" progId="Prism10.Document">
                  <p:embed/>
                </p:oleObj>
              </mc:Choice>
              <mc:Fallback>
                <p:oleObj name="Prism 10" r:id="rId21" imgW="2384697" imgH="266839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2279650" y="8845278"/>
                        <a:ext cx="2384425" cy="2668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8B8F28FE-98DE-49B4-87AA-5953353774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6701002"/>
              </p:ext>
            </p:extLst>
          </p:nvPr>
        </p:nvGraphicFramePr>
        <p:xfrm>
          <a:off x="2393950" y="12113941"/>
          <a:ext cx="2384425" cy="2668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18" name="Prism 10" r:id="rId23" imgW="2384697" imgH="2668395" progId="Prism10.Document">
                  <p:embed/>
                </p:oleObj>
              </mc:Choice>
              <mc:Fallback>
                <p:oleObj name="Prism 10" r:id="rId23" imgW="2384697" imgH="266839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2393950" y="12113941"/>
                        <a:ext cx="2384425" cy="2668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56E24A9C-5C63-4D9E-9D53-EBB31E00B8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334854"/>
              </p:ext>
            </p:extLst>
          </p:nvPr>
        </p:nvGraphicFramePr>
        <p:xfrm>
          <a:off x="4872038" y="11950428"/>
          <a:ext cx="2384425" cy="2833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19" name="Prism 10" r:id="rId25" imgW="2384697" imgH="2832898" progId="Prism10.Document">
                  <p:embed/>
                </p:oleObj>
              </mc:Choice>
              <mc:Fallback>
                <p:oleObj name="Prism 10" r:id="rId25" imgW="2384697" imgH="283289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4872038" y="11950428"/>
                        <a:ext cx="2384425" cy="2833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3BC448DD-CDDD-407A-9293-12A28F11D79C}"/>
              </a:ext>
            </a:extLst>
          </p:cNvPr>
          <p:cNvSpPr txBox="1"/>
          <p:nvPr/>
        </p:nvSpPr>
        <p:spPr>
          <a:xfrm>
            <a:off x="0" y="916887"/>
            <a:ext cx="4686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A. </a:t>
            </a:r>
            <a:endParaRPr lang="en-BE" sz="20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B31F205-8221-45CE-B149-4B2BFCEFCBF6}"/>
              </a:ext>
            </a:extLst>
          </p:cNvPr>
          <p:cNvSpPr txBox="1"/>
          <p:nvPr/>
        </p:nvSpPr>
        <p:spPr>
          <a:xfrm>
            <a:off x="3662091" y="905509"/>
            <a:ext cx="5552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000" b="1" dirty="0"/>
              <a:t>B. </a:t>
            </a:r>
            <a:endParaRPr lang="en-BE" sz="20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85080D2-2FD1-4853-B5F6-1F2B4FC93403}"/>
              </a:ext>
            </a:extLst>
          </p:cNvPr>
          <p:cNvSpPr txBox="1"/>
          <p:nvPr/>
        </p:nvSpPr>
        <p:spPr>
          <a:xfrm>
            <a:off x="7879446" y="917147"/>
            <a:ext cx="5552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000" b="1" dirty="0"/>
              <a:t>C. </a:t>
            </a:r>
            <a:endParaRPr lang="en-BE" sz="20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52C55D3-EB02-401A-8F1F-9AC8297DDC47}"/>
              </a:ext>
            </a:extLst>
          </p:cNvPr>
          <p:cNvSpPr txBox="1"/>
          <p:nvPr/>
        </p:nvSpPr>
        <p:spPr>
          <a:xfrm>
            <a:off x="41525" y="3888892"/>
            <a:ext cx="4644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000" b="1" dirty="0"/>
              <a:t>D. </a:t>
            </a:r>
            <a:endParaRPr lang="en-BE" sz="20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88F818C-550B-4072-A159-08576980D8DF}"/>
              </a:ext>
            </a:extLst>
          </p:cNvPr>
          <p:cNvSpPr txBox="1"/>
          <p:nvPr/>
        </p:nvSpPr>
        <p:spPr>
          <a:xfrm>
            <a:off x="5463316" y="4776779"/>
            <a:ext cx="4644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000" b="1" dirty="0"/>
              <a:t>E. </a:t>
            </a:r>
            <a:endParaRPr lang="en-BE" sz="20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C9061AE-E093-4916-A528-99D45BC17BA5}"/>
              </a:ext>
            </a:extLst>
          </p:cNvPr>
          <p:cNvSpPr txBox="1"/>
          <p:nvPr/>
        </p:nvSpPr>
        <p:spPr>
          <a:xfrm>
            <a:off x="8981396" y="4794382"/>
            <a:ext cx="4644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000" b="1" dirty="0"/>
              <a:t>F. </a:t>
            </a:r>
            <a:endParaRPr lang="en-BE" sz="20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1CC6390-754E-4717-A082-45905B530178}"/>
              </a:ext>
            </a:extLst>
          </p:cNvPr>
          <p:cNvSpPr txBox="1"/>
          <p:nvPr/>
        </p:nvSpPr>
        <p:spPr>
          <a:xfrm>
            <a:off x="1887841" y="8261540"/>
            <a:ext cx="4644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000" b="1" dirty="0"/>
              <a:t>G. </a:t>
            </a:r>
            <a:endParaRPr lang="en-BE" sz="20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CF612C4-115E-4A8A-B448-16505308EB7C}"/>
              </a:ext>
            </a:extLst>
          </p:cNvPr>
          <p:cNvSpPr txBox="1"/>
          <p:nvPr/>
        </p:nvSpPr>
        <p:spPr>
          <a:xfrm>
            <a:off x="1942077" y="11571111"/>
            <a:ext cx="4644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000" b="1" dirty="0"/>
              <a:t>H. </a:t>
            </a:r>
            <a:endParaRPr lang="en-BE" sz="2000" b="1" dirty="0"/>
          </a:p>
        </p:txBody>
      </p:sp>
      <p:sp>
        <p:nvSpPr>
          <p:cNvPr id="25" name="Tekstvak 35">
            <a:extLst>
              <a:ext uri="{FF2B5EF4-FFF2-40B4-BE49-F238E27FC236}">
                <a16:creationId xmlns:a16="http://schemas.microsoft.com/office/drawing/2014/main" id="{54307C1B-C7D3-41BA-9522-6E787FA1EF80}"/>
              </a:ext>
            </a:extLst>
          </p:cNvPr>
          <p:cNvSpPr txBox="1"/>
          <p:nvPr/>
        </p:nvSpPr>
        <p:spPr>
          <a:xfrm>
            <a:off x="230627" y="76489"/>
            <a:ext cx="19886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000" b="1" dirty="0" err="1"/>
              <a:t>Figure</a:t>
            </a:r>
            <a:r>
              <a:rPr lang="nl-BE" sz="2000" b="1" dirty="0"/>
              <a:t> S1</a:t>
            </a:r>
            <a:endParaRPr lang="en-GB" sz="2000" b="1" dirty="0"/>
          </a:p>
        </p:txBody>
      </p:sp>
    </p:spTree>
    <p:extLst>
      <p:ext uri="{BB962C8B-B14F-4D97-AF65-F5344CB8AC3E}">
        <p14:creationId xmlns:p14="http://schemas.microsoft.com/office/powerpoint/2010/main" val="2591484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3ECE3311-8D94-466F-863E-F8EEAB83E8E1}"/>
              </a:ext>
            </a:extLst>
          </p:cNvPr>
          <p:cNvSpPr/>
          <p:nvPr/>
        </p:nvSpPr>
        <p:spPr>
          <a:xfrm>
            <a:off x="381000" y="134729"/>
            <a:ext cx="10668000" cy="42043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 TNF-induced SIRS is characterized by severe metabolic reprogramming. A-D.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nrichr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athway analysis (TRRUST Transcription Factors 2019,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SigDB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allmark 2020 and GO Biological Process 2023) (A-C) and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tascape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athway analysis (D) of the upregulated genes 18h after TNF (1502 genes) with LFC &gt; 1 and p &lt; 0.05.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.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% decrease in body weight of PBS- and TNF treated mice, with body weight before injection set at 100%. n=3-5/group.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.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ight of the inguinal fat pad (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WAT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relative to the total body weight of PBS- and TNF-treated mice (18h). n=3-5/group.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-H.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lculated basal respiration, ATP-linked respiration and maximal respiration of isolated liver mitochondria of PBS- and TNF treated mice, driven by specific respiratory substrates, i.e. 40 µM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lmitoylcarnitine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0.5 mM malate (G) or 10 mM pyruvate (H). n=4-7/group. Bars: mean ± SEM. Each dot represents a single biological replicate. P-values were analyzed with two-way ANOVA (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with unpaired t-test (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*p ≤ 0.05, ns: not significant. </a:t>
            </a:r>
            <a:endParaRPr lang="en-BE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70693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96E1D053-1239-49E6-B7B8-F5AFB8F6B5A2}"/>
              </a:ext>
            </a:extLst>
          </p:cNvPr>
          <p:cNvSpPr txBox="1"/>
          <p:nvPr/>
        </p:nvSpPr>
        <p:spPr>
          <a:xfrm>
            <a:off x="338696" y="521678"/>
            <a:ext cx="4686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A. </a:t>
            </a:r>
            <a:endParaRPr lang="en-BE" sz="20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B4C91C9-2690-45B2-99D2-406C771E51B3}"/>
              </a:ext>
            </a:extLst>
          </p:cNvPr>
          <p:cNvSpPr txBox="1"/>
          <p:nvPr/>
        </p:nvSpPr>
        <p:spPr>
          <a:xfrm>
            <a:off x="5111771" y="1182750"/>
            <a:ext cx="4475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C. </a:t>
            </a:r>
            <a:endParaRPr lang="en-BE" sz="20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B125A12-ECBD-44ED-BAF6-5BE5E4DA704E}"/>
              </a:ext>
            </a:extLst>
          </p:cNvPr>
          <p:cNvSpPr txBox="1"/>
          <p:nvPr/>
        </p:nvSpPr>
        <p:spPr>
          <a:xfrm>
            <a:off x="2598911" y="504753"/>
            <a:ext cx="4555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B. </a:t>
            </a:r>
            <a:endParaRPr lang="en-BE" sz="2000" b="1" dirty="0"/>
          </a:p>
        </p:txBody>
      </p:sp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C2EB4717-BEE1-44EA-8043-67A37C54919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8673886"/>
              </p:ext>
            </p:extLst>
          </p:nvPr>
        </p:nvGraphicFramePr>
        <p:xfrm>
          <a:off x="648576" y="5696364"/>
          <a:ext cx="2514600" cy="2765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64" name="Prism 10" r:id="rId3" imgW="2674460" imgH="2945566" progId="Prism10.Document">
                  <p:embed/>
                </p:oleObj>
              </mc:Choice>
              <mc:Fallback>
                <p:oleObj name="Prism 10" r:id="rId3" imgW="2674460" imgH="294556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48576" y="5696364"/>
                        <a:ext cx="2514600" cy="2765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6CDABDA0-E05D-4286-AE6A-A480B8929701}"/>
              </a:ext>
            </a:extLst>
          </p:cNvPr>
          <p:cNvSpPr txBox="1"/>
          <p:nvPr/>
        </p:nvSpPr>
        <p:spPr>
          <a:xfrm>
            <a:off x="341918" y="3568677"/>
            <a:ext cx="4675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D. </a:t>
            </a:r>
            <a:endParaRPr lang="en-BE" sz="2000" b="1" dirty="0"/>
          </a:p>
        </p:txBody>
      </p:sp>
      <p:graphicFrame>
        <p:nvGraphicFramePr>
          <p:cNvPr id="38" name="Object 37">
            <a:extLst>
              <a:ext uri="{FF2B5EF4-FFF2-40B4-BE49-F238E27FC236}">
                <a16:creationId xmlns:a16="http://schemas.microsoft.com/office/drawing/2014/main" id="{4A5F419D-38E4-4FAA-A4C8-DF626D188E7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5680581"/>
              </p:ext>
            </p:extLst>
          </p:nvPr>
        </p:nvGraphicFramePr>
        <p:xfrm>
          <a:off x="2895984" y="655755"/>
          <a:ext cx="2320925" cy="2716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65" name="Prism 10" r:id="rId5" imgW="2320625" imgH="2715550" progId="Prism10.Document">
                  <p:embed/>
                </p:oleObj>
              </mc:Choice>
              <mc:Fallback>
                <p:oleObj name="Prism 10" r:id="rId5" imgW="2320625" imgH="2715550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40FEA7D4-F8D5-45FC-9497-9DE754098DA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895984" y="655755"/>
                        <a:ext cx="2320925" cy="2716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ct 38">
            <a:extLst>
              <a:ext uri="{FF2B5EF4-FFF2-40B4-BE49-F238E27FC236}">
                <a16:creationId xmlns:a16="http://schemas.microsoft.com/office/drawing/2014/main" id="{B8EBE19C-7839-47C4-9ABE-F0B918045C5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4771561"/>
              </p:ext>
            </p:extLst>
          </p:nvPr>
        </p:nvGraphicFramePr>
        <p:xfrm>
          <a:off x="456862" y="619663"/>
          <a:ext cx="2435225" cy="2781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66" name="Prism 10" r:id="rId7" imgW="2435091" imgH="2781063" progId="Prism10.Document">
                  <p:embed/>
                </p:oleObj>
              </mc:Choice>
              <mc:Fallback>
                <p:oleObj name="Prism 10" r:id="rId7" imgW="2435091" imgH="2781063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7C5E9A2C-6766-4C9E-A2CF-73C021F823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56862" y="619663"/>
                        <a:ext cx="2435225" cy="2781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0" name="Picture 39">
            <a:extLst>
              <a:ext uri="{FF2B5EF4-FFF2-40B4-BE49-F238E27FC236}">
                <a16:creationId xmlns:a16="http://schemas.microsoft.com/office/drawing/2014/main" id="{F8DAC7D9-F9B2-4796-A9F9-CFDC797ADEE1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65" t="59177" r="41385" b="35137"/>
          <a:stretch/>
        </p:blipFill>
        <p:spPr>
          <a:xfrm>
            <a:off x="5606758" y="1991108"/>
            <a:ext cx="3583123" cy="359188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3973FAFC-C983-4837-BE66-86D66E6A8BB6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54" t="73511" r="42385" b="20802"/>
          <a:stretch/>
        </p:blipFill>
        <p:spPr>
          <a:xfrm>
            <a:off x="5606757" y="1621243"/>
            <a:ext cx="3583123" cy="347300"/>
          </a:xfrm>
          <a:prstGeom prst="rect">
            <a:avLst/>
          </a:prstGeom>
        </p:spPr>
      </p:pic>
      <p:sp>
        <p:nvSpPr>
          <p:cNvPr id="42" name="Tekstvak 35">
            <a:extLst>
              <a:ext uri="{FF2B5EF4-FFF2-40B4-BE49-F238E27FC236}">
                <a16:creationId xmlns:a16="http://schemas.microsoft.com/office/drawing/2014/main" id="{696D7084-02BE-411A-AFC8-80ADF0FE585A}"/>
              </a:ext>
            </a:extLst>
          </p:cNvPr>
          <p:cNvSpPr txBox="1"/>
          <p:nvPr/>
        </p:nvSpPr>
        <p:spPr>
          <a:xfrm>
            <a:off x="9127699" y="1616835"/>
            <a:ext cx="19930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400" b="1" dirty="0"/>
              <a:t>SLC25A11 (34 kDa)</a:t>
            </a:r>
          </a:p>
        </p:txBody>
      </p:sp>
      <p:cxnSp>
        <p:nvCxnSpPr>
          <p:cNvPr id="43" name="Rechte verbindingslijn 27">
            <a:extLst>
              <a:ext uri="{FF2B5EF4-FFF2-40B4-BE49-F238E27FC236}">
                <a16:creationId xmlns:a16="http://schemas.microsoft.com/office/drawing/2014/main" id="{04142C25-43F6-451A-89E6-7A00FE137DDC}"/>
              </a:ext>
            </a:extLst>
          </p:cNvPr>
          <p:cNvCxnSpPr>
            <a:cxnSpLocks/>
          </p:cNvCxnSpPr>
          <p:nvPr/>
        </p:nvCxnSpPr>
        <p:spPr>
          <a:xfrm flipV="1">
            <a:off x="5635325" y="1545112"/>
            <a:ext cx="2159764" cy="884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Rechte verbindingslijn 29">
            <a:extLst>
              <a:ext uri="{FF2B5EF4-FFF2-40B4-BE49-F238E27FC236}">
                <a16:creationId xmlns:a16="http://schemas.microsoft.com/office/drawing/2014/main" id="{5520CB86-6760-49B5-8A25-5FB438188107}"/>
              </a:ext>
            </a:extLst>
          </p:cNvPr>
          <p:cNvCxnSpPr>
            <a:cxnSpLocks/>
          </p:cNvCxnSpPr>
          <p:nvPr/>
        </p:nvCxnSpPr>
        <p:spPr>
          <a:xfrm>
            <a:off x="7866347" y="1542811"/>
            <a:ext cx="132353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974EAA59-4DEB-4820-841B-1FA48BA723D3}"/>
              </a:ext>
            </a:extLst>
          </p:cNvPr>
          <p:cNvSpPr txBox="1"/>
          <p:nvPr/>
        </p:nvSpPr>
        <p:spPr>
          <a:xfrm>
            <a:off x="6618966" y="1319839"/>
            <a:ext cx="4667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b="1" dirty="0"/>
              <a:t>PBS</a:t>
            </a:r>
            <a:endParaRPr lang="en-BE" sz="1400" b="1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948EB6F-B660-48A9-8D9F-A9929EE83D7F}"/>
              </a:ext>
            </a:extLst>
          </p:cNvPr>
          <p:cNvSpPr txBox="1"/>
          <p:nvPr/>
        </p:nvSpPr>
        <p:spPr>
          <a:xfrm>
            <a:off x="8293114" y="1309291"/>
            <a:ext cx="4700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b="1" dirty="0"/>
              <a:t>TNF</a:t>
            </a:r>
            <a:endParaRPr lang="en-BE" sz="1400" b="1" dirty="0"/>
          </a:p>
        </p:txBody>
      </p:sp>
      <p:sp>
        <p:nvSpPr>
          <p:cNvPr id="47" name="Tekstvak 36">
            <a:extLst>
              <a:ext uri="{FF2B5EF4-FFF2-40B4-BE49-F238E27FC236}">
                <a16:creationId xmlns:a16="http://schemas.microsoft.com/office/drawing/2014/main" id="{5E648B4D-8AF8-4A64-BDB1-34123AA3D1C4}"/>
              </a:ext>
            </a:extLst>
          </p:cNvPr>
          <p:cNvSpPr txBox="1"/>
          <p:nvPr/>
        </p:nvSpPr>
        <p:spPr>
          <a:xfrm>
            <a:off x="9141752" y="2042519"/>
            <a:ext cx="25933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400" b="1" dirty="0"/>
              <a:t>B-TUBULIN (55 kDa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586CBC3-4C77-4011-A561-DB4031770CFA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b="2189"/>
          <a:stretch/>
        </p:blipFill>
        <p:spPr>
          <a:xfrm>
            <a:off x="305404" y="4100439"/>
            <a:ext cx="11735138" cy="88089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D82C523-B722-41E1-8A99-F5ED7560476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301018" y="5041924"/>
            <a:ext cx="10739524" cy="50394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B10368A-6D08-4534-A0D0-AF591B66AE89}"/>
              </a:ext>
            </a:extLst>
          </p:cNvPr>
          <p:cNvSpPr txBox="1"/>
          <p:nvPr/>
        </p:nvSpPr>
        <p:spPr>
          <a:xfrm>
            <a:off x="1253525" y="4993248"/>
            <a:ext cx="8418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i="1"/>
              <a:t>Slc25a13</a:t>
            </a:r>
            <a:endParaRPr lang="en-BE" sz="1400" i="1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871A126-D392-4830-8E11-D8D332B8E3BB}"/>
              </a:ext>
            </a:extLst>
          </p:cNvPr>
          <p:cNvSpPr txBox="1"/>
          <p:nvPr/>
        </p:nvSpPr>
        <p:spPr>
          <a:xfrm rot="10800000" flipV="1">
            <a:off x="338696" y="5847797"/>
            <a:ext cx="6247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000" b="1" dirty="0"/>
              <a:t>E. </a:t>
            </a:r>
            <a:endParaRPr lang="en-BE" sz="2000" b="1" dirty="0"/>
          </a:p>
        </p:txBody>
      </p:sp>
      <p:sp>
        <p:nvSpPr>
          <p:cNvPr id="21" name="Tekstvak 35">
            <a:extLst>
              <a:ext uri="{FF2B5EF4-FFF2-40B4-BE49-F238E27FC236}">
                <a16:creationId xmlns:a16="http://schemas.microsoft.com/office/drawing/2014/main" id="{4BAF6856-F3AD-4492-8870-7F1D3FB98E34}"/>
              </a:ext>
            </a:extLst>
          </p:cNvPr>
          <p:cNvSpPr txBox="1"/>
          <p:nvPr/>
        </p:nvSpPr>
        <p:spPr>
          <a:xfrm>
            <a:off x="230627" y="76489"/>
            <a:ext cx="19886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000" b="1" dirty="0" err="1"/>
              <a:t>Figure</a:t>
            </a:r>
            <a:r>
              <a:rPr lang="nl-BE" sz="2000" b="1" dirty="0"/>
              <a:t> S2</a:t>
            </a:r>
            <a:endParaRPr lang="en-GB" sz="2000" b="1" dirty="0"/>
          </a:p>
        </p:txBody>
      </p:sp>
    </p:spTree>
    <p:extLst>
      <p:ext uri="{BB962C8B-B14F-4D97-AF65-F5344CB8AC3E}">
        <p14:creationId xmlns:p14="http://schemas.microsoft.com/office/powerpoint/2010/main" val="10132591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DEF4AE84-D9A8-4300-950A-BCCD773AB557}"/>
              </a:ext>
            </a:extLst>
          </p:cNvPr>
          <p:cNvSpPr/>
          <p:nvPr/>
        </p:nvSpPr>
        <p:spPr>
          <a:xfrm>
            <a:off x="542925" y="219174"/>
            <a:ext cx="11106150" cy="29578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: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NF impairs the malate aspartate shuttle leading to a NAD</a:t>
            </a:r>
            <a:r>
              <a:rPr lang="en-US" b="1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NADH deficit. A.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RNA counts of 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c25a11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livers of PBS- and TNF-treated mice. n=3/group.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-C.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stern blot analysis of SLC25A11 (34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protein levels in livers of PBS- and TNF-treated mice, normalized to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tubulin levels (55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n=3-5/group.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.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NF4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IP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eq analysis of the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lc25a13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omoter region visualized via Integrated Genome Browser in wildtype mice. n=4/group.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.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RNA counts of 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c25a13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livers of Hnf4a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l/</a:t>
            </a:r>
            <a:r>
              <a:rPr lang="en-US" baseline="30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l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Hnf4a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ver-i-KO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. n=3/group. Bars: mean ± SEM. Each dot represents a single biological replicate. P-values were analyzed with unpaired t-test (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**p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≤ 0.01,  *p ≤ 0.05, ns: not significant.</a:t>
            </a:r>
            <a:endParaRPr lang="en-BE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95342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Afbeelding 4" descr="Afbeelding met tekst&#10;&#10;Automatisch gegenereerde beschrijving">
            <a:extLst>
              <a:ext uri="{FF2B5EF4-FFF2-40B4-BE49-F238E27FC236}">
                <a16:creationId xmlns:a16="http://schemas.microsoft.com/office/drawing/2014/main" id="{EBBCB6C3-C4CC-46BD-B8F5-B8CE6926275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7282" t="41516" r="13865" b="50980"/>
          <a:stretch/>
        </p:blipFill>
        <p:spPr>
          <a:xfrm>
            <a:off x="1507776" y="1486128"/>
            <a:ext cx="1449865" cy="419304"/>
          </a:xfrm>
          <a:prstGeom prst="rect">
            <a:avLst/>
          </a:prstGeom>
        </p:spPr>
      </p:pic>
      <p:sp>
        <p:nvSpPr>
          <p:cNvPr id="3" name="Tekstvak 36">
            <a:extLst>
              <a:ext uri="{FF2B5EF4-FFF2-40B4-BE49-F238E27FC236}">
                <a16:creationId xmlns:a16="http://schemas.microsoft.com/office/drawing/2014/main" id="{E05260BC-0CDC-4924-A36A-595E93CF327F}"/>
              </a:ext>
            </a:extLst>
          </p:cNvPr>
          <p:cNvSpPr txBox="1"/>
          <p:nvPr/>
        </p:nvSpPr>
        <p:spPr>
          <a:xfrm>
            <a:off x="2957641" y="2025887"/>
            <a:ext cx="14191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400" b="1" dirty="0"/>
              <a:t>ACTIN (42 kDa)</a:t>
            </a:r>
          </a:p>
        </p:txBody>
      </p:sp>
      <p:pic>
        <p:nvPicPr>
          <p:cNvPr id="4" name="Afbeelding 4" descr="Afbeelding met tekst&#10;&#10;Automatisch gegenereerde beschrijving">
            <a:extLst>
              <a:ext uri="{FF2B5EF4-FFF2-40B4-BE49-F238E27FC236}">
                <a16:creationId xmlns:a16="http://schemas.microsoft.com/office/drawing/2014/main" id="{AB9C1965-C7C2-4DC4-A833-68DBD906A5A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963" t="41298" r="56676" b="51198"/>
          <a:stretch/>
        </p:blipFill>
        <p:spPr>
          <a:xfrm>
            <a:off x="402513" y="1486128"/>
            <a:ext cx="1104405" cy="419304"/>
          </a:xfrm>
          <a:prstGeom prst="rect">
            <a:avLst/>
          </a:prstGeom>
        </p:spPr>
      </p:pic>
      <p:pic>
        <p:nvPicPr>
          <p:cNvPr id="5" name="Afbeelding 4" descr="Afbeelding met tekst&#10;&#10;Automatisch gegenereerde beschrijving">
            <a:extLst>
              <a:ext uri="{FF2B5EF4-FFF2-40B4-BE49-F238E27FC236}">
                <a16:creationId xmlns:a16="http://schemas.microsoft.com/office/drawing/2014/main" id="{B8644411-645C-434F-A716-B9DEA9763E4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782" t="56770" r="56857" b="35726"/>
          <a:stretch/>
        </p:blipFill>
        <p:spPr>
          <a:xfrm>
            <a:off x="403371" y="1963526"/>
            <a:ext cx="1104405" cy="419304"/>
          </a:xfrm>
          <a:prstGeom prst="rect">
            <a:avLst/>
          </a:prstGeom>
        </p:spPr>
      </p:pic>
      <p:pic>
        <p:nvPicPr>
          <p:cNvPr id="6" name="Afbeelding 4" descr="Afbeelding met tekst&#10;&#10;Automatisch gegenereerde beschrijving">
            <a:extLst>
              <a:ext uri="{FF2B5EF4-FFF2-40B4-BE49-F238E27FC236}">
                <a16:creationId xmlns:a16="http://schemas.microsoft.com/office/drawing/2014/main" id="{C59F2394-96BA-44EC-8D37-01BE9E83B85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7502" t="56677" r="13645" b="35819"/>
          <a:stretch/>
        </p:blipFill>
        <p:spPr>
          <a:xfrm>
            <a:off x="1507776" y="1963526"/>
            <a:ext cx="1449865" cy="419304"/>
          </a:xfrm>
          <a:prstGeom prst="rect">
            <a:avLst/>
          </a:prstGeom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D5CE1F77-AEC7-4A9A-8515-218D07F0F53D}"/>
              </a:ext>
            </a:extLst>
          </p:cNvPr>
          <p:cNvCxnSpPr>
            <a:cxnSpLocks/>
          </p:cNvCxnSpPr>
          <p:nvPr/>
        </p:nvCxnSpPr>
        <p:spPr>
          <a:xfrm flipH="1">
            <a:off x="442802" y="1420595"/>
            <a:ext cx="100486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15C4B83B-1180-4458-A219-2EF6E1E429F5}"/>
              </a:ext>
            </a:extLst>
          </p:cNvPr>
          <p:cNvCxnSpPr>
            <a:cxnSpLocks/>
          </p:cNvCxnSpPr>
          <p:nvPr/>
        </p:nvCxnSpPr>
        <p:spPr>
          <a:xfrm flipH="1">
            <a:off x="1523135" y="1420595"/>
            <a:ext cx="1374588" cy="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A12E2C6B-872C-487E-A8D1-498FD6BDAAE1}"/>
              </a:ext>
            </a:extLst>
          </p:cNvPr>
          <p:cNvSpPr txBox="1"/>
          <p:nvPr/>
        </p:nvSpPr>
        <p:spPr>
          <a:xfrm>
            <a:off x="469447" y="1177864"/>
            <a:ext cx="10134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b="1" dirty="0"/>
              <a:t>Slc25a13</a:t>
            </a:r>
            <a:r>
              <a:rPr lang="nl-BE" sz="1400" b="1" baseline="30000" dirty="0"/>
              <a:t>+/+</a:t>
            </a:r>
            <a:endParaRPr lang="en-BE" sz="14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136437-CEA4-4B01-B508-0AE866A5571D}"/>
              </a:ext>
            </a:extLst>
          </p:cNvPr>
          <p:cNvSpPr txBox="1"/>
          <p:nvPr/>
        </p:nvSpPr>
        <p:spPr>
          <a:xfrm>
            <a:off x="1764239" y="1177864"/>
            <a:ext cx="9685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1400" b="1" dirty="0"/>
              <a:t>Slc25a13</a:t>
            </a:r>
            <a:r>
              <a:rPr lang="nl-BE" sz="1400" b="1" baseline="30000" dirty="0"/>
              <a:t>-/-</a:t>
            </a:r>
            <a:endParaRPr lang="en-BE" sz="1400" b="1" dirty="0"/>
          </a:p>
        </p:txBody>
      </p:sp>
      <p:sp>
        <p:nvSpPr>
          <p:cNvPr id="11" name="Tekstvak 35">
            <a:extLst>
              <a:ext uri="{FF2B5EF4-FFF2-40B4-BE49-F238E27FC236}">
                <a16:creationId xmlns:a16="http://schemas.microsoft.com/office/drawing/2014/main" id="{88CBEAD9-54D7-4EFE-BE3D-5D62178E5A3C}"/>
              </a:ext>
            </a:extLst>
          </p:cNvPr>
          <p:cNvSpPr txBox="1"/>
          <p:nvPr/>
        </p:nvSpPr>
        <p:spPr>
          <a:xfrm>
            <a:off x="2957641" y="1557689"/>
            <a:ext cx="19930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400" b="1" dirty="0"/>
              <a:t>SLC25A13 (74 kDa)</a:t>
            </a:r>
          </a:p>
        </p:txBody>
      </p:sp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3D8AD395-CF44-4CCA-B8E6-61A4ABC667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4742506"/>
              </p:ext>
            </p:extLst>
          </p:nvPr>
        </p:nvGraphicFramePr>
        <p:xfrm>
          <a:off x="3889005" y="7269581"/>
          <a:ext cx="4067175" cy="2786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375" name="Prism 10" r:id="rId4" imgW="4393242" imgH="3008199" progId="Prism10.Document">
                  <p:embed/>
                </p:oleObj>
              </mc:Choice>
              <mc:Fallback>
                <p:oleObj name="Prism 10" r:id="rId4" imgW="4393242" imgH="3008199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3D8AD395-CF44-4CCA-B8E6-61A4ABC6674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889005" y="7269581"/>
                        <a:ext cx="4067175" cy="2786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E4921DEC-56F3-4304-8C0A-CD39AF5598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7459188"/>
              </p:ext>
            </p:extLst>
          </p:nvPr>
        </p:nvGraphicFramePr>
        <p:xfrm>
          <a:off x="4473317" y="934070"/>
          <a:ext cx="2454410" cy="21690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376" name="Prism 10" r:id="rId6" imgW="2771648" imgH="2448819" progId="Prism10.Document">
                  <p:embed/>
                </p:oleObj>
              </mc:Choice>
              <mc:Fallback>
                <p:oleObj name="Prism 10" r:id="rId6" imgW="2771648" imgH="2448819" progId="Prism10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E4921DEC-56F3-4304-8C0A-CD39AF55987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473317" y="934070"/>
                        <a:ext cx="2454410" cy="21690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6" name="TextBox 45">
            <a:extLst>
              <a:ext uri="{FF2B5EF4-FFF2-40B4-BE49-F238E27FC236}">
                <a16:creationId xmlns:a16="http://schemas.microsoft.com/office/drawing/2014/main" id="{2F7C80D9-6DA3-4E67-8F0B-A912D1071289}"/>
              </a:ext>
            </a:extLst>
          </p:cNvPr>
          <p:cNvSpPr txBox="1"/>
          <p:nvPr/>
        </p:nvSpPr>
        <p:spPr>
          <a:xfrm>
            <a:off x="-23983" y="976572"/>
            <a:ext cx="4686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A. </a:t>
            </a:r>
            <a:endParaRPr lang="en-BE" sz="2000" b="1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1417233-2432-46CD-A7E5-6BF01397C08E}"/>
              </a:ext>
            </a:extLst>
          </p:cNvPr>
          <p:cNvSpPr txBox="1"/>
          <p:nvPr/>
        </p:nvSpPr>
        <p:spPr>
          <a:xfrm>
            <a:off x="4202906" y="971971"/>
            <a:ext cx="4555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B. </a:t>
            </a:r>
            <a:endParaRPr lang="en-BE" sz="2000" b="1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9048595-AE43-404B-8AD6-8FB17E178FC7}"/>
              </a:ext>
            </a:extLst>
          </p:cNvPr>
          <p:cNvSpPr txBox="1"/>
          <p:nvPr/>
        </p:nvSpPr>
        <p:spPr>
          <a:xfrm>
            <a:off x="-24924" y="3359904"/>
            <a:ext cx="4675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D. </a:t>
            </a:r>
            <a:endParaRPr lang="en-BE" sz="2000" b="1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18ACA8F-F15E-4B3B-9FF6-9ED7428E1D69}"/>
              </a:ext>
            </a:extLst>
          </p:cNvPr>
          <p:cNvSpPr txBox="1"/>
          <p:nvPr/>
        </p:nvSpPr>
        <p:spPr>
          <a:xfrm>
            <a:off x="6305053" y="3363024"/>
            <a:ext cx="4363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E. </a:t>
            </a:r>
            <a:endParaRPr lang="en-BE" sz="2000" b="1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B62B2F6-3E60-48A4-80BA-C74FD95E6147}"/>
              </a:ext>
            </a:extLst>
          </p:cNvPr>
          <p:cNvSpPr txBox="1"/>
          <p:nvPr/>
        </p:nvSpPr>
        <p:spPr>
          <a:xfrm>
            <a:off x="0" y="6869471"/>
            <a:ext cx="4081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F. </a:t>
            </a:r>
            <a:endParaRPr lang="en-BE" sz="2000" b="1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46CCA52-101D-4CD6-82BC-65945AF10A3A}"/>
              </a:ext>
            </a:extLst>
          </p:cNvPr>
          <p:cNvSpPr txBox="1"/>
          <p:nvPr/>
        </p:nvSpPr>
        <p:spPr>
          <a:xfrm>
            <a:off x="3747146" y="6869471"/>
            <a:ext cx="4748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G. </a:t>
            </a:r>
            <a:endParaRPr lang="en-BE" sz="2000" b="1" dirty="0"/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6F782639-9C2B-449E-A287-EABFFC9013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34594588"/>
              </p:ext>
            </p:extLst>
          </p:nvPr>
        </p:nvGraphicFramePr>
        <p:xfrm>
          <a:off x="8534318" y="7118014"/>
          <a:ext cx="3753294" cy="29376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377" name="Prism 10" r:id="rId8" imgW="4821228" imgH="3773118" progId="Prism10.Document">
                  <p:embed/>
                </p:oleObj>
              </mc:Choice>
              <mc:Fallback>
                <p:oleObj name="Prism 10" r:id="rId8" imgW="4821228" imgH="377311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534318" y="7118014"/>
                        <a:ext cx="3753294" cy="29376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1" name="Object 60">
            <a:extLst>
              <a:ext uri="{FF2B5EF4-FFF2-40B4-BE49-F238E27FC236}">
                <a16:creationId xmlns:a16="http://schemas.microsoft.com/office/drawing/2014/main" id="{1AEE7F5D-F5E3-4656-AEC6-B1F60ACC54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0755042"/>
              </p:ext>
            </p:extLst>
          </p:nvPr>
        </p:nvGraphicFramePr>
        <p:xfrm>
          <a:off x="6748471" y="3568329"/>
          <a:ext cx="3838239" cy="27634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378" name="Prism 10" r:id="rId10" imgW="4178349" imgH="3008199" progId="Prism10.Document">
                  <p:embed/>
                </p:oleObj>
              </mc:Choice>
              <mc:Fallback>
                <p:oleObj name="Prism 10" r:id="rId10" imgW="4178349" imgH="3008199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88D7E9FA-9DD7-4439-9903-7CEB350289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748471" y="3568329"/>
                        <a:ext cx="3838239" cy="27634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1BAA16BD-BE8D-4070-8A43-8E538729BB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2730047"/>
              </p:ext>
            </p:extLst>
          </p:nvPr>
        </p:nvGraphicFramePr>
        <p:xfrm>
          <a:off x="271833" y="6665806"/>
          <a:ext cx="3228975" cy="3894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379" name="Prism 10" r:id="rId12" imgW="3228790" imgH="3894785" progId="Prism10.Document">
                  <p:embed/>
                </p:oleObj>
              </mc:Choice>
              <mc:Fallback>
                <p:oleObj name="Prism 10" r:id="rId12" imgW="3228790" imgH="389478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71833" y="6665806"/>
                        <a:ext cx="3228975" cy="3894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TextBox 27">
            <a:extLst>
              <a:ext uri="{FF2B5EF4-FFF2-40B4-BE49-F238E27FC236}">
                <a16:creationId xmlns:a16="http://schemas.microsoft.com/office/drawing/2014/main" id="{C39FF996-2333-40C2-A149-350D269B05D1}"/>
              </a:ext>
            </a:extLst>
          </p:cNvPr>
          <p:cNvSpPr txBox="1"/>
          <p:nvPr/>
        </p:nvSpPr>
        <p:spPr>
          <a:xfrm>
            <a:off x="8297715" y="6869471"/>
            <a:ext cx="4732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H. </a:t>
            </a:r>
            <a:endParaRPr lang="en-BE" sz="2000" b="1" dirty="0"/>
          </a:p>
        </p:txBody>
      </p:sp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528BDFC3-A436-4DD8-A665-0C08E75FF4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7232508"/>
              </p:ext>
            </p:extLst>
          </p:nvPr>
        </p:nvGraphicFramePr>
        <p:xfrm>
          <a:off x="6875825" y="669652"/>
          <a:ext cx="5411787" cy="2868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380" name="Prism 10" r:id="rId14" imgW="5411193" imgH="2869254" progId="Prism10.Document">
                  <p:embed/>
                </p:oleObj>
              </mc:Choice>
              <mc:Fallback>
                <p:oleObj name="Prism 10" r:id="rId14" imgW="5411193" imgH="286925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6875825" y="669652"/>
                        <a:ext cx="5411787" cy="2868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TextBox 29">
            <a:extLst>
              <a:ext uri="{FF2B5EF4-FFF2-40B4-BE49-F238E27FC236}">
                <a16:creationId xmlns:a16="http://schemas.microsoft.com/office/drawing/2014/main" id="{CDD7ABB2-6D3B-4B9F-8A93-21E295C5AA86}"/>
              </a:ext>
            </a:extLst>
          </p:cNvPr>
          <p:cNvSpPr txBox="1"/>
          <p:nvPr/>
        </p:nvSpPr>
        <p:spPr>
          <a:xfrm>
            <a:off x="6606957" y="931642"/>
            <a:ext cx="4475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C</a:t>
            </a:r>
            <a:r>
              <a:rPr lang="nl-BE" sz="2000" b="1"/>
              <a:t>. </a:t>
            </a:r>
            <a:endParaRPr lang="en-BE" sz="2000" b="1" dirty="0"/>
          </a:p>
        </p:txBody>
      </p:sp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038DEC83-73FC-49D8-948E-76CF384233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118706"/>
              </p:ext>
            </p:extLst>
          </p:nvPr>
        </p:nvGraphicFramePr>
        <p:xfrm>
          <a:off x="97977" y="3695586"/>
          <a:ext cx="5353050" cy="2868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381" name="Prism 10" r:id="rId16" imgW="5353240" imgH="2869254" progId="Prism10.Document">
                  <p:embed/>
                </p:oleObj>
              </mc:Choice>
              <mc:Fallback>
                <p:oleObj name="Prism 10" r:id="rId16" imgW="5353240" imgH="286925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97977" y="3695586"/>
                        <a:ext cx="5353050" cy="2868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Tekstvak 35">
            <a:extLst>
              <a:ext uri="{FF2B5EF4-FFF2-40B4-BE49-F238E27FC236}">
                <a16:creationId xmlns:a16="http://schemas.microsoft.com/office/drawing/2014/main" id="{67DBE978-C58E-4C05-965E-D56DB370DA14}"/>
              </a:ext>
            </a:extLst>
          </p:cNvPr>
          <p:cNvSpPr txBox="1"/>
          <p:nvPr/>
        </p:nvSpPr>
        <p:spPr>
          <a:xfrm>
            <a:off x="230627" y="76489"/>
            <a:ext cx="19886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000" b="1" dirty="0" err="1"/>
              <a:t>Figure</a:t>
            </a:r>
            <a:r>
              <a:rPr lang="nl-BE" sz="2000" b="1" dirty="0"/>
              <a:t> S3</a:t>
            </a:r>
            <a:endParaRPr lang="en-GB" sz="2000" b="1" dirty="0"/>
          </a:p>
        </p:txBody>
      </p:sp>
    </p:spTree>
    <p:extLst>
      <p:ext uri="{BB962C8B-B14F-4D97-AF65-F5344CB8AC3E}">
        <p14:creationId xmlns:p14="http://schemas.microsoft.com/office/powerpoint/2010/main" val="23602410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5B779278-0D70-4975-8784-28124D1DFC74}"/>
              </a:ext>
            </a:extLst>
          </p:cNvPr>
          <p:cNvSpPr/>
          <p:nvPr/>
        </p:nvSpPr>
        <p:spPr>
          <a:xfrm>
            <a:off x="333375" y="202684"/>
            <a:ext cx="11525250" cy="54508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: </a:t>
            </a:r>
            <a:r>
              <a:rPr lang="en-US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itrin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knockout results in acute lethality and enhanced metabolic dysfunctions in TNF-induced SIRS. A-B.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stern blot analysis of SLC25A13 (74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protein levels in livers of Slc25a13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Slc25a13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, normalized to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ctin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evels (42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n=3-4/group.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-D.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ody temperature (C) and blood lactate levels (D) in PBS- and TNF-treated Slc25a13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Slc25a13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 0h, 4h, 6h and 8h post-injection. P-values of TNF injected mice were compared with their respective PBS control n=5-7/group.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.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nrichr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athway analysis (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SigDB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allmark 2020) of the unique upregulated genes (1227) 8h after TNF in Slc25a13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 with LFC &gt; 1 and p &lt; 0.05.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.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eatmap depicting the LFC (TNF versus PBS) of inflammatory and endothelial activation genes in Slc25a13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Slc25a13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.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.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nrichr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athway analysis (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EA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2022) of the unique downregulated genes 8h after TNF in Slc25a13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 (2164 genes) with LFC &lt; -1 and p &lt; 0.05. 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.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catter plot depicting the LFCs of differentially expressed genes in 18h TNF-treated Slc25a13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 compared to 8h TNF-treated Slc25a13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. The black line represents the diagonal (r=1) and the red line indicates the real slope (r= 0.7814) of the data. Data were analyzed with linear regression. Bars: mean ± SEM. Each dot represents a single biological replicate. P-values were analyzed with unpaired t-test (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or with two-way ANOVA (C-D). ***p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≤ 0.001,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*p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≤ 0.01,  *p ≤ 0.05. </a:t>
            </a:r>
            <a:endParaRPr lang="en-BE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08830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8F9C246-70E6-40C1-BDAB-7ECEBC1996D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767466"/>
              </p:ext>
            </p:extLst>
          </p:nvPr>
        </p:nvGraphicFramePr>
        <p:xfrm>
          <a:off x="4454278" y="8329866"/>
          <a:ext cx="3140075" cy="3678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03" name="Prism 10" r:id="rId3" imgW="3140601" imgH="3678448" progId="Prism10.Document">
                  <p:embed/>
                </p:oleObj>
              </mc:Choice>
              <mc:Fallback>
                <p:oleObj name="Prism 10" r:id="rId3" imgW="3140601" imgH="367844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454278" y="8329866"/>
                        <a:ext cx="3140075" cy="3678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2C25535-0416-4F70-8E21-A6D24D217A3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4592680"/>
              </p:ext>
            </p:extLst>
          </p:nvPr>
        </p:nvGraphicFramePr>
        <p:xfrm>
          <a:off x="7771906" y="8374499"/>
          <a:ext cx="3217863" cy="3554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04" name="Prism 10" r:id="rId5" imgW="3218351" imgH="3554981" progId="Prism10.Document">
                  <p:embed/>
                </p:oleObj>
              </mc:Choice>
              <mc:Fallback>
                <p:oleObj name="Prism 10" r:id="rId5" imgW="3218351" imgH="3554981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771906" y="8374499"/>
                        <a:ext cx="3217863" cy="3554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B3D76C0D-4570-4AAD-A004-C8B9E707B3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7317030"/>
              </p:ext>
            </p:extLst>
          </p:nvPr>
        </p:nvGraphicFramePr>
        <p:xfrm>
          <a:off x="4513015" y="12112046"/>
          <a:ext cx="3217863" cy="3294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05" name="Prism 10" r:id="rId7" imgW="3218351" imgH="3294369" progId="Prism10.Document">
                  <p:embed/>
                </p:oleObj>
              </mc:Choice>
              <mc:Fallback>
                <p:oleObj name="Prism 10" r:id="rId7" imgW="3218351" imgH="329436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513015" y="12112046"/>
                        <a:ext cx="3217863" cy="3294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5A1C56D2-1036-4098-9BE3-1C271DDBB1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8938779"/>
              </p:ext>
            </p:extLst>
          </p:nvPr>
        </p:nvGraphicFramePr>
        <p:xfrm>
          <a:off x="7877332" y="11752262"/>
          <a:ext cx="3140075" cy="3551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06" name="Prism 10" r:id="rId9" imgW="3140601" imgH="3550661" progId="Prism10.Document">
                  <p:embed/>
                </p:oleObj>
              </mc:Choice>
              <mc:Fallback>
                <p:oleObj name="Prism 10" r:id="rId9" imgW="3140601" imgH="3550661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877332" y="11752262"/>
                        <a:ext cx="3140075" cy="3551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BDC37105-F1FC-4E0B-8E1C-ED4E2CEEF087}"/>
              </a:ext>
            </a:extLst>
          </p:cNvPr>
          <p:cNvSpPr txBox="1"/>
          <p:nvPr/>
        </p:nvSpPr>
        <p:spPr>
          <a:xfrm>
            <a:off x="4998832" y="4534925"/>
            <a:ext cx="1763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b="1" dirty="0"/>
              <a:t>10 mM Pyruvate</a:t>
            </a:r>
            <a:endParaRPr lang="en-BE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2ABEF31-7BDE-495B-A658-6F30CB416A2B}"/>
              </a:ext>
            </a:extLst>
          </p:cNvPr>
          <p:cNvSpPr txBox="1"/>
          <p:nvPr/>
        </p:nvSpPr>
        <p:spPr>
          <a:xfrm>
            <a:off x="2261583" y="455085"/>
            <a:ext cx="7810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b="1" dirty="0"/>
              <a:t>40 µM Palmitoylcarnitine + 0.5 mM Malate</a:t>
            </a:r>
            <a:endParaRPr lang="en-BE" b="1" dirty="0"/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5D975727-B9E7-4300-BAFC-75618DCC55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4323773"/>
              </p:ext>
            </p:extLst>
          </p:nvPr>
        </p:nvGraphicFramePr>
        <p:xfrm>
          <a:off x="909638" y="4775454"/>
          <a:ext cx="3216275" cy="3554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07" name="Prism 10" r:id="rId11" imgW="3216911" imgH="3554981" progId="Prism10.Document">
                  <p:embed/>
                </p:oleObj>
              </mc:Choice>
              <mc:Fallback>
                <p:oleObj name="Prism 10" r:id="rId11" imgW="3216911" imgH="3554981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909638" y="4775454"/>
                        <a:ext cx="3216275" cy="3554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5D06BEC1-C66B-423C-BC4D-088D1AE4156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8974648"/>
              </p:ext>
            </p:extLst>
          </p:nvPr>
        </p:nvGraphicFramePr>
        <p:xfrm>
          <a:off x="4276725" y="4854829"/>
          <a:ext cx="3216275" cy="3502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08" name="Prism 10" r:id="rId13" imgW="3216911" imgH="3501707" progId="Prism10.Document">
                  <p:embed/>
                </p:oleObj>
              </mc:Choice>
              <mc:Fallback>
                <p:oleObj name="Prism 10" r:id="rId13" imgW="3216911" imgH="350170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276725" y="4854829"/>
                        <a:ext cx="3216275" cy="3502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1A547981-6F79-4DA8-88EF-2B6179BE42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1705228"/>
              </p:ext>
            </p:extLst>
          </p:nvPr>
        </p:nvGraphicFramePr>
        <p:xfrm>
          <a:off x="7634288" y="4835525"/>
          <a:ext cx="3216275" cy="3536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09" name="Prism 10" r:id="rId15" imgW="3216911" imgH="3536983" progId="Prism10.Document">
                  <p:embed/>
                </p:oleObj>
              </mc:Choice>
              <mc:Fallback>
                <p:oleObj name="Prism 10" r:id="rId15" imgW="3216911" imgH="353698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7634288" y="4835525"/>
                        <a:ext cx="3216275" cy="3536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B8A26FDB-73EA-4407-B9F5-3142955E36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434300"/>
              </p:ext>
            </p:extLst>
          </p:nvPr>
        </p:nvGraphicFramePr>
        <p:xfrm>
          <a:off x="7629525" y="671513"/>
          <a:ext cx="3216275" cy="3729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10" name="Prism 10" r:id="rId17" imgW="3216911" imgH="3728842" progId="Prism10.Document">
                  <p:embed/>
                </p:oleObj>
              </mc:Choice>
              <mc:Fallback>
                <p:oleObj name="Prism 10" r:id="rId17" imgW="3216911" imgH="372884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7629525" y="671513"/>
                        <a:ext cx="3216275" cy="3729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1F45BA22-8C17-400D-9C98-C5B1285C81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4635514"/>
              </p:ext>
            </p:extLst>
          </p:nvPr>
        </p:nvGraphicFramePr>
        <p:xfrm>
          <a:off x="4276725" y="887413"/>
          <a:ext cx="3216275" cy="3509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11" name="Prism 10" r:id="rId19" imgW="3216911" imgH="3509266" progId="Prism10.Document">
                  <p:embed/>
                </p:oleObj>
              </mc:Choice>
              <mc:Fallback>
                <p:oleObj name="Prism 10" r:id="rId19" imgW="3216911" imgH="350926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276725" y="887413"/>
                        <a:ext cx="3216275" cy="3509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C347F4C1-95F6-4298-BB2B-84DF103CDC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5450951"/>
              </p:ext>
            </p:extLst>
          </p:nvPr>
        </p:nvGraphicFramePr>
        <p:xfrm>
          <a:off x="873125" y="946150"/>
          <a:ext cx="3216275" cy="345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624" name="Prism 10" r:id="rId21" imgW="3216911" imgH="3454552" progId="Prism10.Document">
                  <p:embed/>
                </p:oleObj>
              </mc:Choice>
              <mc:Fallback>
                <p:oleObj name="Prism 10" r:id="rId21" imgW="3216911" imgH="345455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873125" y="946150"/>
                        <a:ext cx="3216275" cy="345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2953D0C9-B424-4317-AA40-32BD41454716}"/>
              </a:ext>
            </a:extLst>
          </p:cNvPr>
          <p:cNvSpPr txBox="1"/>
          <p:nvPr/>
        </p:nvSpPr>
        <p:spPr>
          <a:xfrm>
            <a:off x="638363" y="437007"/>
            <a:ext cx="4686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A. </a:t>
            </a:r>
            <a:endParaRPr lang="en-BE" sz="20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13B41FC-504F-4428-84F5-25E74B8AAB49}"/>
              </a:ext>
            </a:extLst>
          </p:cNvPr>
          <p:cNvSpPr txBox="1"/>
          <p:nvPr/>
        </p:nvSpPr>
        <p:spPr>
          <a:xfrm>
            <a:off x="657603" y="4526274"/>
            <a:ext cx="4555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B. </a:t>
            </a:r>
            <a:endParaRPr lang="en-BE" sz="20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0EC1CC7-4F2B-4C16-95BB-8E2A1AE28FEF}"/>
              </a:ext>
            </a:extLst>
          </p:cNvPr>
          <p:cNvSpPr txBox="1"/>
          <p:nvPr/>
        </p:nvSpPr>
        <p:spPr>
          <a:xfrm>
            <a:off x="685859" y="9086080"/>
            <a:ext cx="4475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C. </a:t>
            </a:r>
            <a:endParaRPr lang="en-BE" sz="20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DC38DB7-CAE3-42ED-895A-D0F44CCCAC4A}"/>
              </a:ext>
            </a:extLst>
          </p:cNvPr>
          <p:cNvSpPr txBox="1"/>
          <p:nvPr/>
        </p:nvSpPr>
        <p:spPr>
          <a:xfrm>
            <a:off x="4516563" y="8466833"/>
            <a:ext cx="4675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D. </a:t>
            </a:r>
            <a:endParaRPr lang="en-BE" sz="20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751AD3F-60F7-40C5-AA35-166C9B36514C}"/>
              </a:ext>
            </a:extLst>
          </p:cNvPr>
          <p:cNvSpPr txBox="1"/>
          <p:nvPr/>
        </p:nvSpPr>
        <p:spPr>
          <a:xfrm flipH="1">
            <a:off x="7877332" y="8466833"/>
            <a:ext cx="896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000" b="1" dirty="0"/>
              <a:t>E. </a:t>
            </a:r>
            <a:endParaRPr lang="en-BE" sz="20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F325515-6104-4122-BED2-A787C3C7BAAB}"/>
              </a:ext>
            </a:extLst>
          </p:cNvPr>
          <p:cNvSpPr txBox="1"/>
          <p:nvPr/>
        </p:nvSpPr>
        <p:spPr>
          <a:xfrm>
            <a:off x="4546250" y="12089290"/>
            <a:ext cx="4081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000" b="1" dirty="0"/>
              <a:t>F. </a:t>
            </a:r>
            <a:endParaRPr lang="en-BE" sz="2000" b="1" dirty="0"/>
          </a:p>
        </p:txBody>
      </p:sp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033E4F92-4BB2-438B-BC7F-8A7433D14BC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2652192"/>
              </p:ext>
            </p:extLst>
          </p:nvPr>
        </p:nvGraphicFramePr>
        <p:xfrm>
          <a:off x="869703" y="9617927"/>
          <a:ext cx="3140075" cy="37869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625" name="Prism 10" r:id="rId23" imgW="3228790" imgH="3894785" progId="Prism10.Document">
                  <p:embed/>
                </p:oleObj>
              </mc:Choice>
              <mc:Fallback>
                <p:oleObj name="Prism 10" r:id="rId23" imgW="3228790" imgH="389478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869703" y="9617927"/>
                        <a:ext cx="3140075" cy="37869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0CAC2AE1-2411-4954-B9E9-7167CAEF0EFD}"/>
              </a:ext>
            </a:extLst>
          </p:cNvPr>
          <p:cNvSpPr txBox="1"/>
          <p:nvPr/>
        </p:nvSpPr>
        <p:spPr>
          <a:xfrm>
            <a:off x="7877332" y="12089290"/>
            <a:ext cx="5825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000" b="1" dirty="0"/>
              <a:t>G. </a:t>
            </a:r>
            <a:endParaRPr lang="en-BE" sz="2000" b="1" dirty="0"/>
          </a:p>
        </p:txBody>
      </p:sp>
      <p:sp>
        <p:nvSpPr>
          <p:cNvPr id="23" name="Tekstvak 35">
            <a:extLst>
              <a:ext uri="{FF2B5EF4-FFF2-40B4-BE49-F238E27FC236}">
                <a16:creationId xmlns:a16="http://schemas.microsoft.com/office/drawing/2014/main" id="{C5C87A1F-D634-434D-A831-C76957A73FBE}"/>
              </a:ext>
            </a:extLst>
          </p:cNvPr>
          <p:cNvSpPr txBox="1"/>
          <p:nvPr/>
        </p:nvSpPr>
        <p:spPr>
          <a:xfrm>
            <a:off x="230627" y="76489"/>
            <a:ext cx="19886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000" b="1" dirty="0" err="1"/>
              <a:t>Figure</a:t>
            </a:r>
            <a:r>
              <a:rPr lang="nl-BE" sz="2000" b="1" dirty="0"/>
              <a:t> S4</a:t>
            </a:r>
            <a:endParaRPr lang="en-GB" sz="2000" b="1" dirty="0"/>
          </a:p>
        </p:txBody>
      </p:sp>
    </p:spTree>
    <p:extLst>
      <p:ext uri="{BB962C8B-B14F-4D97-AF65-F5344CB8AC3E}">
        <p14:creationId xmlns:p14="http://schemas.microsoft.com/office/powerpoint/2010/main" val="4364241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A881171D-57F2-4C90-9E88-BD8460BDD936}"/>
              </a:ext>
            </a:extLst>
          </p:cNvPr>
          <p:cNvSpPr/>
          <p:nvPr/>
        </p:nvSpPr>
        <p:spPr>
          <a:xfrm>
            <a:off x="390525" y="148376"/>
            <a:ext cx="11410950" cy="33733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: Supplementary statistical analysis of seahorse data and vascular permeability. A-B.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lculated basal respiration, ATP-linked respiration and maximal respiration of isolated liver mitochondria of PBS- and TNF-treated Slc25a13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Slc25a13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, driven by specific respiratory substrates, i.e. 40 µM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lmitoylcarnitine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0.5 mM malate (A) or 10 mM pyruvate (B). n=6/group.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.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eatmap depicting the LFC (TNF versus PBS) of endothelial activation and damage genes in Slc25a13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Slc25a13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.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-G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Vascular permeability in heart (D), kidney (E), lung (F) and spleen (G) of PBS- and TNF-treated Slc25a13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Slc25a13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. n=4-7/group. Bars: mean ± SEM. Each dot represents a single biological replicate. P-values were analyzed with two-way ANOVA (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, D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****p 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≤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0.0001, ***p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≤ 0.001,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*p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≤ 0.01,  *p ≤ 0.05, ns: not significant. </a:t>
            </a:r>
            <a:endParaRPr lang="en-BE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0898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275</TotalTime>
  <Words>988</Words>
  <Application>Microsoft Office PowerPoint</Application>
  <PresentationFormat>Custom</PresentationFormat>
  <Paragraphs>49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uise Nuyttens</dc:creator>
  <cp:lastModifiedBy>Louise Nuyttens</cp:lastModifiedBy>
  <cp:revision>345</cp:revision>
  <cp:lastPrinted>2025-09-15T18:02:58Z</cp:lastPrinted>
  <dcterms:created xsi:type="dcterms:W3CDTF">2024-11-25T10:45:14Z</dcterms:created>
  <dcterms:modified xsi:type="dcterms:W3CDTF">2025-09-23T18:18:21Z</dcterms:modified>
</cp:coreProperties>
</file>